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4" r:id="rId3"/>
    <p:sldId id="261" r:id="rId4"/>
    <p:sldId id="262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855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396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805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00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151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978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056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119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715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087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584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786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794958"/>
            <a:ext cx="9144000" cy="715004"/>
          </a:xfrm>
        </p:spPr>
        <p:txBody>
          <a:bodyPr>
            <a:noAutofit/>
          </a:bodyPr>
          <a:lstStyle/>
          <a:p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3.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GSEA of 377 genes comprising putative down-stream regulatory targets of both LTR7 and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LTR5_Hs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loci. Related to Table 8.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2465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100564" y="306934"/>
            <a:ext cx="4053022" cy="4942935"/>
          </a:xfrm>
          <a:prstGeom prst="rect">
            <a:avLst/>
          </a:prstGeom>
        </p:spPr>
      </p:pic>
      <p:pic>
        <p:nvPicPr>
          <p:cNvPr id="4098" name="Picture 2" descr="https://appyters.maayanlab.cloud/Enrichment_Analysis_Visualizer/de9db2d07a2083211c48d8c789f663008e201394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0905" y="1630393"/>
            <a:ext cx="6176514" cy="34074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001993" y="0"/>
            <a:ext cx="60902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77 genes linked by GREAT with both LTR7 and LTR5_Hs loci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7259674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858326" y="487396"/>
            <a:ext cx="4252823" cy="503782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01993" y="0"/>
            <a:ext cx="60902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77 genes linked by GREAT with both LTR7 and LTR5_Hs loci </a:t>
            </a:r>
          </a:p>
        </p:txBody>
      </p:sp>
      <p:pic>
        <p:nvPicPr>
          <p:cNvPr id="1026" name="Picture 2" descr="https://appyters.maayanlab.cloud/Enrichment_Analysis_Visualizer/1877a3d937d1be755a80c74649c70ba87ded0d68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3650" y="1837426"/>
            <a:ext cx="6167890" cy="35538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483093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41346" y="584149"/>
            <a:ext cx="4109057" cy="4936325"/>
          </a:xfrm>
          <a:prstGeom prst="rect">
            <a:avLst/>
          </a:prstGeom>
        </p:spPr>
      </p:pic>
      <p:pic>
        <p:nvPicPr>
          <p:cNvPr id="2050" name="Picture 2" descr="https://appyters.maayanlab.cloud/Enrichment_Analysis_Visualizer/9a8c73f16b819f8cce127f0271ed22e1158cec0c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5027" y="1858360"/>
            <a:ext cx="6280030" cy="34900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001993" y="0"/>
            <a:ext cx="60902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77 genes linked by GREAT with both LTR7 and LTR5_Hs loci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93210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969534" y="313930"/>
            <a:ext cx="4071671" cy="5031069"/>
          </a:xfrm>
          <a:prstGeom prst="rect">
            <a:avLst/>
          </a:prstGeom>
        </p:spPr>
      </p:pic>
      <p:pic>
        <p:nvPicPr>
          <p:cNvPr id="3074" name="Picture 2" descr="https://appyters.maayanlab.cloud/Enrichment_Analysis_Visualizer/021812608fd576cd4d067425dc9bf0284ac4936d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1891" y="1682150"/>
            <a:ext cx="6357671" cy="34246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001993" y="0"/>
            <a:ext cx="60902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77 genes linked by GREAT with both LTR7 and LTR5_Hs loci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137298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73</Words>
  <Application>Microsoft Office PowerPoint</Application>
  <PresentationFormat>Widescreen</PresentationFormat>
  <Paragraphs>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ementary Figure S3. GSEA of 377 genes comprising putative down-stream regulatory targets of both LTR7 and LTR5_Hs loci. Related to Table 8.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377 LTR7-linked  genes among 935 LTR5_Hs linked genes</dc:title>
  <dc:creator>Guennadi Glinskii</dc:creator>
  <cp:lastModifiedBy>Guennadi Glinskii</cp:lastModifiedBy>
  <cp:revision>23</cp:revision>
  <dcterms:created xsi:type="dcterms:W3CDTF">2022-03-05T10:12:02Z</dcterms:created>
  <dcterms:modified xsi:type="dcterms:W3CDTF">2022-04-21T05:39:40Z</dcterms:modified>
</cp:coreProperties>
</file>